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D8C84-104B-4C81-B97C-282BC7E9F7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46FB7-9874-4F3C-B7C9-2FF4B34775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9FE50-DCCC-4773-A93B-E37C796E77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F070A-3318-41A3-A413-47E3F50B1F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0860E-20DA-4110-A148-9D96811FB3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B7A0E-36CF-4F7C-9B60-CF27C5810B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169CF-B651-4B18-8ABF-9B137F0B8E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2EABB-1EC2-4BA5-B81A-6237595CE9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7EF1D-21C3-448C-8320-DDD08C5749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A00EA-3533-4906-91FF-9B74CB7E51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DB91D-2030-450A-94B9-6B1839A26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BB424-2C14-470F-8719-0E3EDEB51C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FBF26C-C7BD-40D7-9D93-6C54382C3CD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096920" y="177804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87640" y="1701720"/>
            <a:ext cx="5076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840040" y="1701720"/>
            <a:ext cx="85680" cy="1526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82920" y="1701720"/>
            <a:ext cx="17640" cy="152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96920" y="223524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087640" y="2158920"/>
            <a:ext cx="5076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40040" y="2158920"/>
            <a:ext cx="85680" cy="1526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96920" y="261612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087640" y="2540160"/>
            <a:ext cx="5076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82920" y="2540160"/>
            <a:ext cx="1764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15000" y="1015920"/>
            <a:ext cx="5076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767560" y="942840"/>
            <a:ext cx="1651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QQLLLANGGDPGT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807160" y="1731240"/>
            <a:ext cx="27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NMDPNGAPHFFKGINNGMDANM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729400" y="1778040"/>
            <a:ext cx="85680" cy="1522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815080" y="2358720"/>
            <a:ext cx="76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AATQ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805360" y="2463840"/>
            <a:ext cx="1764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096920" y="139716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832360" y="3090240"/>
            <a:ext cx="16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IANASPAMHAKSIQ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864000" y="838080"/>
            <a:ext cx="262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Spliced isoforms of MoSom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334120" y="1015920"/>
            <a:ext cx="304560" cy="1524240"/>
          </a:xfrm>
          <a:custGeom>
            <a:avLst/>
            <a:gdLst>
              <a:gd name="textAreaLeft" fmla="*/ 194760 w 304560"/>
              <a:gd name="textAreaRight" fmla="*/ 304920 w 304560"/>
              <a:gd name="textAreaTop" fmla="*/ 39600 h 1524240"/>
              <a:gd name="textAreaBottom" fmla="*/ 1484640 h 15242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81040" y="1573200"/>
            <a:ext cx="110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Missed a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096920" y="299736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087640" y="2921040"/>
            <a:ext cx="5076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382920" y="3301920"/>
            <a:ext cx="17640" cy="152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633200" y="3035160"/>
            <a:ext cx="110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Extra aa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：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14520" y="4414680"/>
            <a:ext cx="122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GG_047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096920" y="3378240"/>
            <a:ext cx="2811600" cy="0"/>
          </a:xfrm>
          <a:prstGeom prst="line">
            <a:avLst/>
          </a:prstGeom>
          <a:ln w="50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138400" y="3301920"/>
            <a:ext cx="54000" cy="15264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745240" y="3149640"/>
            <a:ext cx="54000" cy="15228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505320" y="3911760"/>
            <a:ext cx="360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352680" y="360684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0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762120" y="121932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768240" y="1600200"/>
            <a:ext cx="381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66800" y="205272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63560" y="242424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52400" y="2827440"/>
            <a:ext cx="381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54200" y="320040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楷体_GB2312"/>
              </a:rPr>
              <a:t>I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09480" y="3808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09480" y="40528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33520" y="4800600"/>
            <a:ext cx="800100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NMGNMNAMGGIGGPGVPPGPQQPPQQGTDNRHAVYLNTYIYDYLLRNEMYDAARGVLKSGQPINVEQDRENGLGGDSMDTDSKDDVNSKKPEDLPAPILGSATPDISFLYEWFSMFWDLLNASKGKYAPAQVSQYITHTQNHTRMRQQ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QQEMLRGMRPDMAAQQQQFLMMNRPNGNMNMMNKNQ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HRGAIANTQNQMQMLAQQKQGQMQRDPSDMDGNRQRP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SADNAPSPSKRVRLDGGPGFNPGQPGMMPNGRPGAPGMPNQQT</a:t>
            </a:r>
            <a:r>
              <a:rPr b="1" lang="en-US" sz="1000" spc="-1" strike="noStrike">
                <a:solidFill>
                  <a:srgbClr val="00ff00"/>
                </a:solidFill>
                <a:latin typeface="Arial"/>
              </a:rPr>
              <a:t>QQLLLANGGDPGT</a:t>
            </a:r>
            <a:r>
              <a:rPr b="1" lang="en-US" sz="1000" spc="-1" strike="noStrike">
                <a:solidFill>
                  <a:srgbClr val="0000ff"/>
                </a:solidFill>
                <a:latin typeface="Arial"/>
              </a:rPr>
              <a:t>AIANASPAMHAKSIQ</a:t>
            </a:r>
            <a:r>
              <a:rPr b="1" lang="en-US" sz="1000" spc="-1" strike="noStrike">
                <a:solidFill>
                  <a:srgbClr val="00ff00"/>
                </a:solidFill>
                <a:latin typeface="Arial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AQNLQQHHGNQMPNKPMPGPNAPQGQGSPMVASGPDGTQLNAFYNAQEPMGAAPNGGMRPGVPATQNGSNHALQDYQMQLMLLEQQNKKRLMMARQEQDGIQGQGMARADGPGGPGPAGGPGGPAGAPNGPQFQGASPQGARPGASPNPSEQMKRAAGQMNNGSMGSPLPEGAQNRE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NNPMNFMG</a:t>
            </a: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TNMDPNGAPHFFKGINNGMDANM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QMNGGMNRPP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PGQQPFSQMNPQQQAMMRQQQMQQQQQGGPNGQPMPGQWQGGPNGQMPGGPQGGPQQGPVHGTPQQRAMPPPSAPTAAANSNANQRN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ASPQVSNAAPPTPSQANKAAPKKKD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AKDK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AA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Q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KSNANLNAAGGATPAADGGNDGEAPTPATPMTPMAASQQNFNKPGPAAGGAPPQQMPNGQPPAAAPTAAPVAPQQHNDPNQFNMEGGGMDFNLDFANPLASGDVLNDFDFDSFLHDNVEDTGFGFDGPGLNFEGTNEIG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SER</cp:lastModifiedBy>
  <dcterms:modified xsi:type="dcterms:W3CDTF">2011-09-22T11:24:49Z</dcterms:modified>
  <cp:revision>4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